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0"/>
  </p:notesMasterIdLst>
  <p:sldIdLst>
    <p:sldId id="260" r:id="rId2"/>
    <p:sldId id="261" r:id="rId3"/>
    <p:sldId id="263" r:id="rId4"/>
    <p:sldId id="262" r:id="rId5"/>
    <p:sldId id="265" r:id="rId6"/>
    <p:sldId id="258" r:id="rId7"/>
    <p:sldId id="256" r:id="rId8"/>
    <p:sldId id="259" r:id="rId9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5" d="100"/>
          <a:sy n="65" d="100"/>
        </p:scale>
        <p:origin x="153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BAC2B6A-7B0E-4D09-A994-F8959B5259A6}" type="datetimeFigureOut">
              <a:rPr lang="en-US" smtClean="0"/>
              <a:t>2/12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709F239-17D1-401D-B428-0DDDA35397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98653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709F239-17D1-401D-B428-0DDDA353978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699237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709F239-17D1-401D-B428-0DDDA3539789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206434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709F239-17D1-401D-B428-0DDDA3539789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08275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709F239-17D1-401D-B428-0DDDA3539789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563833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709F239-17D1-401D-B428-0DDDA3539789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533787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709F239-17D1-401D-B428-0DDDA3539789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8312264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709F239-17D1-401D-B428-0DDDA3539789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7908169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709F239-17D1-401D-B428-0DDDA3539789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56262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48288-5B94-4446-A909-1C7BBCA2D816}" type="datetimeFigureOut">
              <a:rPr lang="en-US" smtClean="0"/>
              <a:t>2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0C41F-0027-4BBA-9760-64184F3021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94163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48288-5B94-4446-A909-1C7BBCA2D816}" type="datetimeFigureOut">
              <a:rPr lang="en-US" smtClean="0"/>
              <a:t>2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0C41F-0027-4BBA-9760-64184F3021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9999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48288-5B94-4446-A909-1C7BBCA2D816}" type="datetimeFigureOut">
              <a:rPr lang="en-US" smtClean="0"/>
              <a:t>2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0C41F-0027-4BBA-9760-64184F3021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27562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48288-5B94-4446-A909-1C7BBCA2D816}" type="datetimeFigureOut">
              <a:rPr lang="en-US" smtClean="0"/>
              <a:t>2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0C41F-0027-4BBA-9760-64184F3021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7497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48288-5B94-4446-A909-1C7BBCA2D816}" type="datetimeFigureOut">
              <a:rPr lang="en-US" smtClean="0"/>
              <a:t>2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0C41F-0027-4BBA-9760-64184F3021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95450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48288-5B94-4446-A909-1C7BBCA2D816}" type="datetimeFigureOut">
              <a:rPr lang="en-US" smtClean="0"/>
              <a:t>2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0C41F-0027-4BBA-9760-64184F3021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93336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48288-5B94-4446-A909-1C7BBCA2D816}" type="datetimeFigureOut">
              <a:rPr lang="en-US" smtClean="0"/>
              <a:t>2/1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0C41F-0027-4BBA-9760-64184F3021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74469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48288-5B94-4446-A909-1C7BBCA2D816}" type="datetimeFigureOut">
              <a:rPr lang="en-US" smtClean="0"/>
              <a:t>2/1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0C41F-0027-4BBA-9760-64184F3021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68923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48288-5B94-4446-A909-1C7BBCA2D816}" type="datetimeFigureOut">
              <a:rPr lang="en-US" smtClean="0"/>
              <a:t>2/1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0C41F-0027-4BBA-9760-64184F3021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93179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48288-5B94-4446-A909-1C7BBCA2D816}" type="datetimeFigureOut">
              <a:rPr lang="en-US" smtClean="0"/>
              <a:t>2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0C41F-0027-4BBA-9760-64184F3021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93513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48288-5B94-4446-A909-1C7BBCA2D816}" type="datetimeFigureOut">
              <a:rPr lang="en-US" smtClean="0"/>
              <a:t>2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0C41F-0027-4BBA-9760-64184F3021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1965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048288-5B94-4446-A909-1C7BBCA2D816}" type="datetimeFigureOut">
              <a:rPr lang="en-US" smtClean="0"/>
              <a:t>2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50C41F-0027-4BBA-9760-64184F3021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444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3E6FAE5B-E449-4FA5-A508-AE35736ED9CD}"/>
              </a:ext>
            </a:extLst>
          </p:cNvPr>
          <p:cNvSpPr txBox="1"/>
          <p:nvPr/>
        </p:nvSpPr>
        <p:spPr>
          <a:xfrm>
            <a:off x="553064" y="5436624"/>
            <a:ext cx="69575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(S1): Shows example of </a:t>
            </a:r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mf-1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nds at 674 bp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2E15A49-F0C5-4CF5-B36F-A296E4A3649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 bwMode="gray">
          <a:xfrm>
            <a:off x="1170744" y="693174"/>
            <a:ext cx="6802512" cy="41897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501215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3E6FAE5B-E449-4FA5-A508-AE35736ED9CD}"/>
              </a:ext>
            </a:extLst>
          </p:cNvPr>
          <p:cNvSpPr txBox="1"/>
          <p:nvPr/>
        </p:nvSpPr>
        <p:spPr>
          <a:xfrm>
            <a:off x="696861" y="5692305"/>
            <a:ext cx="7750278" cy="6651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Bef>
                <a:spcPts val="300"/>
              </a:spcBef>
              <a:spcAft>
                <a:spcPts val="300"/>
              </a:spcAft>
            </a:pP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(S2): Shows example of </a:t>
            </a:r>
            <a:r>
              <a:rPr lang="en-GB" b="1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mPr1</a:t>
            </a:r>
            <a:r>
              <a:rPr lang="en-US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b="1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mPr1</a:t>
            </a:r>
            <a:r>
              <a:rPr lang="en-US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llelic variant of strain K279a) 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nds at 1621 bp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A72CA28-801E-4840-B6B6-A92DB9F70BE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25557" y="500577"/>
            <a:ext cx="5265174" cy="48625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557441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3E6FAE5B-E449-4FA5-A508-AE35736ED9CD}"/>
              </a:ext>
            </a:extLst>
          </p:cNvPr>
          <p:cNvSpPr txBox="1"/>
          <p:nvPr/>
        </p:nvSpPr>
        <p:spPr>
          <a:xfrm>
            <a:off x="553064" y="5436624"/>
            <a:ext cx="69575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(S3): Shows example of </a:t>
            </a:r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mPr1 (Internal fragment of the stmPr1 gene) 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nds at 868 bp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51E85EA-08F3-444A-A3C4-7923CEC9C4C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63329" y="335117"/>
            <a:ext cx="6017341" cy="46801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780825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3E6FAE5B-E449-4FA5-A508-AE35736ED9CD}"/>
              </a:ext>
            </a:extLst>
          </p:cNvPr>
          <p:cNvSpPr txBox="1"/>
          <p:nvPr/>
        </p:nvSpPr>
        <p:spPr>
          <a:xfrm>
            <a:off x="553064" y="5436624"/>
            <a:ext cx="69575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(S4): Shows example of </a:t>
            </a:r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mPr2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nds at 1764 bp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DA97A13-FB85-46A2-B228-15E826330B7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40310" y="210363"/>
            <a:ext cx="5357607" cy="49735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204375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3E6FAE5B-E449-4FA5-A508-AE35736ED9CD}"/>
              </a:ext>
            </a:extLst>
          </p:cNvPr>
          <p:cNvSpPr txBox="1"/>
          <p:nvPr/>
        </p:nvSpPr>
        <p:spPr>
          <a:xfrm>
            <a:off x="553064" y="5820082"/>
            <a:ext cx="69575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(S5): Shows example of </a:t>
            </a:r>
            <a:r>
              <a:rPr lang="en-GB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GB" b="1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lt3773 locus</a:t>
            </a:r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nds at 1342 bp.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7292041-5938-4825-B976-1AB403B6956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61536" y="439761"/>
            <a:ext cx="4469491" cy="49968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7747750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3E6FAE5B-E449-4FA5-A508-AE35736ED9CD}"/>
              </a:ext>
            </a:extLst>
          </p:cNvPr>
          <p:cNvSpPr txBox="1"/>
          <p:nvPr/>
        </p:nvSpPr>
        <p:spPr>
          <a:xfrm>
            <a:off x="553064" y="5436624"/>
            <a:ext cx="69575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(S6): Shows example of </a:t>
            </a:r>
            <a:r>
              <a:rPr lang="en-US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pfF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nd at 700 bp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9623A96-AB29-4B08-8273-2620F78E83A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 bwMode="gray">
          <a:xfrm>
            <a:off x="1227803" y="546107"/>
            <a:ext cx="6688394" cy="43451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0140927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4499F0A-B60E-4CB5-974A-E256C352D05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 bwMode="gray">
          <a:xfrm>
            <a:off x="1519084" y="246104"/>
            <a:ext cx="5364031" cy="547882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E6FAE5B-E449-4FA5-A508-AE35736ED9CD}"/>
              </a:ext>
            </a:extLst>
          </p:cNvPr>
          <p:cNvSpPr txBox="1"/>
          <p:nvPr/>
        </p:nvSpPr>
        <p:spPr>
          <a:xfrm>
            <a:off x="505132" y="6085553"/>
            <a:ext cx="69575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(S7): Shows examples of </a:t>
            </a:r>
            <a:r>
              <a:rPr lang="en-US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mlA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nd at 1222 bp.</a:t>
            </a:r>
          </a:p>
        </p:txBody>
      </p:sp>
    </p:spTree>
    <p:extLst>
      <p:ext uri="{BB962C8B-B14F-4D97-AF65-F5344CB8AC3E}">
        <p14:creationId xmlns:p14="http://schemas.microsoft.com/office/powerpoint/2010/main" val="97826394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3E6FAE5B-E449-4FA5-A508-AE35736ED9CD}"/>
              </a:ext>
            </a:extLst>
          </p:cNvPr>
          <p:cNvSpPr txBox="1"/>
          <p:nvPr/>
        </p:nvSpPr>
        <p:spPr>
          <a:xfrm>
            <a:off x="1059554" y="5552040"/>
            <a:ext cx="69575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(S8): Shows example of </a:t>
            </a:r>
            <a:r>
              <a:rPr lang="en-US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gM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nd at 2750 bp.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B5F84DED-1890-436C-A2A1-5605D01E61F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 bwMode="gray">
          <a:xfrm>
            <a:off x="1073248" y="1121294"/>
            <a:ext cx="6930165" cy="32294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273767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</TotalTime>
  <Words>129</Words>
  <Application>Microsoft Office PowerPoint</Application>
  <PresentationFormat>On-screen Show (4:3)</PresentationFormat>
  <Paragraphs>16</Paragraphs>
  <Slides>8</Slides>
  <Notes>8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ira g</dc:creator>
  <cp:lastModifiedBy>amira g</cp:lastModifiedBy>
  <cp:revision>3</cp:revision>
  <dcterms:created xsi:type="dcterms:W3CDTF">2021-12-03T15:16:14Z</dcterms:created>
  <dcterms:modified xsi:type="dcterms:W3CDTF">2022-02-12T18:44:03Z</dcterms:modified>
</cp:coreProperties>
</file>